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31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6" name="作成者" initials="A" lastIdx="0" clrIdx="5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84" autoAdjust="0"/>
    <p:restoredTop sz="87850" autoAdjust="0"/>
  </p:normalViewPr>
  <p:slideViewPr>
    <p:cSldViewPr snapToGrid="0">
      <p:cViewPr varScale="1">
        <p:scale>
          <a:sx n="64" d="100"/>
          <a:sy n="64" d="100"/>
        </p:scale>
        <p:origin x="488" y="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140" d="100"/>
          <a:sy n="140" d="100"/>
        </p:scale>
        <p:origin x="-5048" y="-68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05EA3C-4BDC-4640-982F-389704D6D94D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C91F8E-DDD2-44B7-B7C0-F7638604C8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7744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FA5DB4-6F89-1237-EB4E-7D8A1718F6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B56C093-538D-6752-4AF7-BA720235C8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BEF12F-2A31-991E-6FD8-19E5C8F249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95F5E6F-6666-E454-7BAE-101495ED8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433D079-8E6F-0098-8403-202B0D060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9872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1AE696-E06A-E511-224F-62A68CE681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6B0E322-95E9-7077-9267-D9281FABAC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319D4F-8964-7006-5F1F-E46E7532C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049E05-BFA8-26E7-855B-FFE226175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0969472-9AF1-A476-10EE-125F38D42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3383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9F1AB9A-53AD-9B40-F1AD-B9F8ED4B62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14D5B5E-68CC-C0B1-CA5E-FF8FEFFEDD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B7D39E-4613-B4DF-DEC8-2334DC69E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98DF90B-55A8-9CBE-B653-54C9A13316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B08153-DCFD-89DE-5241-78F85D46A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617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62A3AD-C133-23F0-EE2F-359A6BFB52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33A8C21-C0F5-241C-B4A4-C55C5D29C1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0221FC-94FF-1F9B-B694-471B3A18E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D103DF-75B4-43BD-AA71-3925D0D072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2B68D0-2C98-63C1-0691-9A32C9CD3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2742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345862-91FE-90B9-61E1-05B9153A58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A2125D2-3735-6350-9CBD-6214B3F4E9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184C7C-3480-7956-7084-4EC386347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C852F5-A0B5-9C45-2A43-191C36E6FD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B84BB2-DC4F-9B3B-1A3F-995837E6B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1417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E5989E-5CFD-0A1C-7ACA-A150E12451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B94E10B-E3DD-EA82-5524-695B3B3F00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FBA902C-DD74-27FB-1539-068349B616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B764B80-3111-5983-2F44-C9886F9F9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2D703E5-5F3F-B784-5790-4066636B8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6048E94-5899-CC0A-6BBA-048855C46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9910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3F8AD6-117D-7B37-57FC-88BC4959A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91D3A7-988A-5E18-BB8D-B3DC24DF3C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6D3C4B1-4097-9703-1677-D0512F1D81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4AD7045-7A34-1B8E-5E90-1424ECD0FB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4AE6DDC-3E89-3D5A-073B-4E0E77F40A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2E7BDD5-7AFF-FAAA-2569-D04A26FBA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C08C4CC-C18A-E0FF-434F-44B6C016FD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5BEF1B1-271D-6D3E-B85E-C1ADEC5D64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6060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8F8A56-C434-DC53-12D9-B6DC92BA97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2C272C2-C487-E6FA-6C2A-E8A1FC098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CEFC788-D8C4-FC85-B621-824D50D9D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55C2AAB-734D-4EF7-C52F-5ABBCAB39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4852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70B54E4-FA4D-09D9-48BF-5F07B53C3A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9FF7E73-D74C-F3D2-5211-5E0DE60FC0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39EAE95-34A2-2C1A-96D1-A89E57F31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0789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5622B5-79CE-EBEC-3386-5B48EBEF0E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0DC89EB-65D3-4827-8856-988E92B7C1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64AE76E-9481-9EC6-3325-6AE3C8A5BB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8FF962C-310D-E0A8-EB37-93C3A954E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0D63030-45E8-284B-E9AA-5DB611406F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E43E033-5BC2-5A55-B67A-85988C75F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2554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62ABE2-A185-53A8-6A16-9A14E7DC89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54E42AF-41EC-DD0B-C774-DAE4369C67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DFC3851-45AA-E89C-24B2-757B2114EE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9B11643-86D7-7DCC-5419-FEC3704CB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0C27F15-8BC7-9BE3-754F-10788F6EB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A6DC22E-F1E3-69B6-95E5-FD9CA1D970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553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3E307F8-C841-B27B-75FD-74271BE252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D292C82-EDB3-9E66-FC95-96A9B1E4D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5CFFD69-8FB0-7F6B-D7F4-985F12E5DE8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861E03-67D8-40A9-B2A4-3B2B12F54859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CB8707-7D7A-99BB-00EB-49508EB003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9E2B15-ED12-0BE7-4185-5729D13F307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B7739-7ABA-4954-A9AA-CE66F8AECF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7064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2998914D-29EB-EF39-4CAA-480B7F724C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07181" y="371475"/>
            <a:ext cx="6084000" cy="607453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71A81F8-6A4A-EDCF-80F6-E74336D98F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60" y="371475"/>
            <a:ext cx="6084000" cy="6074538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ABDF214-139E-CDAC-35FB-4E666FFAF76A}"/>
              </a:ext>
            </a:extLst>
          </p:cNvPr>
          <p:cNvSpPr txBox="1"/>
          <p:nvPr/>
        </p:nvSpPr>
        <p:spPr>
          <a:xfrm>
            <a:off x="3646710" y="3096101"/>
            <a:ext cx="2050863" cy="3351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=0.002 (Log-rank test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48FDBB4-3976-2472-685D-6CA9CB310199}"/>
              </a:ext>
            </a:extLst>
          </p:cNvPr>
          <p:cNvSpPr txBox="1"/>
          <p:nvPr/>
        </p:nvSpPr>
        <p:spPr>
          <a:xfrm>
            <a:off x="9840858" y="3096101"/>
            <a:ext cx="2176502" cy="3351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=0.06 (Log-rank test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1923C5A-4DE7-835F-B34D-15CFC3C0D63B}"/>
              </a:ext>
            </a:extLst>
          </p:cNvPr>
          <p:cNvSpPr txBox="1"/>
          <p:nvPr/>
        </p:nvSpPr>
        <p:spPr>
          <a:xfrm>
            <a:off x="725049" y="629575"/>
            <a:ext cx="4968000" cy="3385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rude K-M curves for TKI (Megalopolis)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97D11DB-EEF6-B6D5-6256-82642089BE9C}"/>
              </a:ext>
            </a:extLst>
          </p:cNvPr>
          <p:cNvSpPr txBox="1"/>
          <p:nvPr/>
        </p:nvSpPr>
        <p:spPr>
          <a:xfrm>
            <a:off x="6848884" y="629575"/>
            <a:ext cx="4968000" cy="3385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rude K-M curves for TKI (Others)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1379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4-07-06T18:05:31Z</dcterms:created>
  <dcterms:modified xsi:type="dcterms:W3CDTF">2024-11-27T02:47:54Z</dcterms:modified>
</cp:coreProperties>
</file>